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FB157A3-EDF0-45F6-ABC2-3EFB301C0595}" v="3" dt="2025-11-02T21:18:48.040"/>
    <p1510:client id="{C18B60B0-73FF-4BDB-98BD-0413E8BE7A0E}" v="1" dt="2025-11-02T22:26:25.85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4" d="100"/>
          <a:sy n="104" d="100"/>
        </p:scale>
        <p:origin x="284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obel, Raymond" userId="682ea7fd-2081-4ef7-9ccf-cc036b672067" providerId="ADAL" clId="{327064EF-D6E0-4CA7-937D-5219C7D36AD4}"/>
    <pc:docChg chg="custSel addSld modSld">
      <pc:chgData name="Sobel, Raymond" userId="682ea7fd-2081-4ef7-9ccf-cc036b672067" providerId="ADAL" clId="{327064EF-D6E0-4CA7-937D-5219C7D36AD4}" dt="2025-11-02T22:26:11.085" v="171" actId="20577"/>
      <pc:docMkLst>
        <pc:docMk/>
      </pc:docMkLst>
      <pc:sldChg chg="addSp delSp modSp new mod">
        <pc:chgData name="Sobel, Raymond" userId="682ea7fd-2081-4ef7-9ccf-cc036b672067" providerId="ADAL" clId="{327064EF-D6E0-4CA7-937D-5219C7D36AD4}" dt="2025-11-02T22:26:11.085" v="171" actId="20577"/>
        <pc:sldMkLst>
          <pc:docMk/>
          <pc:sldMk cId="3744564216" sldId="256"/>
        </pc:sldMkLst>
        <pc:spChg chg="add mod">
          <ac:chgData name="Sobel, Raymond" userId="682ea7fd-2081-4ef7-9ccf-cc036b672067" providerId="ADAL" clId="{327064EF-D6E0-4CA7-937D-5219C7D36AD4}" dt="2025-11-02T22:26:11.085" v="171" actId="20577"/>
          <ac:spMkLst>
            <pc:docMk/>
            <pc:sldMk cId="3744564216" sldId="256"/>
            <ac:spMk id="4" creationId="{2571C028-8524-3A49-B9BB-8EE9AB795E3A}"/>
          </ac:spMkLst>
        </pc:spChg>
        <pc:picChg chg="add del mod">
          <ac:chgData name="Sobel, Raymond" userId="682ea7fd-2081-4ef7-9ccf-cc036b672067" providerId="ADAL" clId="{327064EF-D6E0-4CA7-937D-5219C7D36AD4}" dt="2025-11-02T22:22:23.480" v="138" actId="478"/>
          <ac:picMkLst>
            <pc:docMk/>
            <pc:sldMk cId="3744564216" sldId="256"/>
            <ac:picMk id="3" creationId="{A11ABE44-0B99-3AE0-A94A-378154AA6F58}"/>
          </ac:picMkLst>
        </pc:picChg>
        <pc:picChg chg="add mod">
          <ac:chgData name="Sobel, Raymond" userId="682ea7fd-2081-4ef7-9ccf-cc036b672067" providerId="ADAL" clId="{327064EF-D6E0-4CA7-937D-5219C7D36AD4}" dt="2025-11-02T22:25:50.681" v="168" actId="1076"/>
          <ac:picMkLst>
            <pc:docMk/>
            <pc:sldMk cId="3744564216" sldId="256"/>
            <ac:picMk id="5" creationId="{4FF207AB-348F-7936-A552-F782B788735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978EDB-5F52-504E-97C6-A58E6BA224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16248E-A6CB-A0B5-2F06-CFE70D7386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AD152-6223-FC67-BF48-71CEB6A20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62267-1483-2BBD-06AC-774E5BB220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DB06AF-E14D-26ED-89A6-839AA71C26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18829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87FB7C-EFDC-AF1E-2AA6-7FD5897423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75CE5A-5827-2D33-B031-DCF353340C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C5A576-779E-94CA-2733-A66E72C94C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C3DEB2-62FD-13F1-44A0-E43E7A6912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27EA6E-2FDE-2B10-3F2A-D920DD4E56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66133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27685F6-C049-9913-DC0B-3B932D24BC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0B2C-459A-7758-7E8B-60724828F4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99E73B-90C7-C91E-F23A-0709C3B795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FFAE5C-B99D-EB01-94EE-C1DD58D4C6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51A5F1-9906-EED8-625B-3DBE174ECC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868595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F15C59-234F-3007-C855-6DC0DCC7CD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DFD54E-FBCC-90D1-C52E-219A14FD853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EEAD6F-B7E7-D2EA-B3E6-0733366F1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733E4A-D556-E858-4657-451077D83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E9E92D-D13C-B5B5-41BE-EC3F3BF202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668580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9D775-F6CC-373E-59E9-733A894CE0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1B44E5-651F-69E9-3CE4-1436A25682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55FF7D-AAA0-725B-F73F-16B3F54D59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4376F9-434B-1D06-34AE-67C72936CE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3FF49B-3211-2746-B004-E3DFB4114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76749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6E1BE0-DF8B-CEC0-4E13-210724536C6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85A6F0-46BA-1392-9D3A-EEB8258B868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A89A05A-1D67-3E58-E8B7-E83A7645007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171AE80-E74F-C2B9-A2F8-E5D5762A6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2D860F-C230-57C9-8AC8-A64B1E1D9A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1C2CF1-987A-1A10-D7D9-BF0AB76A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59592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08E09E-9365-5B5A-BAEC-D42176719B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564CF-5010-8670-804F-CD9855723DA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5ACD0DF-19A1-CB89-074E-65A71F129AA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8948A43-BF6C-1500-41C6-8F4C085BBB3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B323149-969B-9BD6-94FF-9C390A1E0D6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2A5624B-6731-25C0-F627-7AC526064D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02E5339-9E26-AD35-1FA0-22B23F551E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6FF9A9-220E-694C-3D43-436FBCB4F9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371824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1CF4A7-74EA-B0B7-3279-4F7F806AB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D2642C7-A43D-55C1-B0D4-AF26FBC11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ECAF761-5CF3-B0E2-8D04-A582558617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7EC4D3C-2B19-D9AE-6D0B-00C3B80D27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48754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8631BC2-3DB5-00C1-3E39-3EA84D79B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A26FB49-24F2-76FB-4436-C83BAF79C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857FD6B-7ED2-DE1D-1A31-274D87D875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667648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8B65CA6-DEDC-D345-87C6-2B647EF61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34FB66-34CB-D54F-901B-463F4198711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1214F8F-DC2A-0D68-95CD-23642BBBD80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B8E8DCF-BE26-1F58-67E6-F7C8B1D8D1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1E1A05B-8F0C-48A7-AF25-189B9C348F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28F1C86-B81A-97F0-9463-68727196DB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494211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526A7AE-AB11-C684-A9BF-54A664F0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8C5981-53C6-3AAA-2484-E58FBD5E9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2BFB993-6317-0FF6-AA42-9CEA85DBB7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A1BD64-834E-2C58-636C-C93A525BB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34D3E0-9EC3-7CB2-D8BA-BED2A52AF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85EC89-BCEF-D373-D4B6-046AA04049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03478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8EABF90-C8C6-258C-D545-2FDDE03F65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87894B-552E-2C03-AAEA-665D50462D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40C522-B832-62D4-48D3-4D791369137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3B2ED70-4546-4B3B-86D8-757D3E550BEF}" type="datetimeFigureOut">
              <a:rPr lang="en-US" smtClean="0"/>
              <a:t>11/2/2025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51F338-9539-B24F-421B-DFBC140BEA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41CA7C-86C7-4830-0048-93FD2296F5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203558D-F888-499F-8842-A769F302AD7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36608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571C028-8524-3A49-B9BB-8EE9AB795E3A}"/>
              </a:ext>
            </a:extLst>
          </p:cNvPr>
          <p:cNvSpPr txBox="1"/>
          <p:nvPr/>
        </p:nvSpPr>
        <p:spPr>
          <a:xfrm>
            <a:off x="311889" y="5447207"/>
            <a:ext cx="1168872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9. Preliminary validation of proteomic findings by immunofluorescence analysis. Immunofluorescence staining confirmed increased expression of thrombospondin-4 (THBS4, in green), identified by proteomic analysis, in the XMEA patient d. Co-staining with sarcoglycan (red) was used to delineate the sarcolemma. Nuclei were counterstained with DAPI (blue). Scale bar: 50 μm.</a:t>
            </a:r>
          </a:p>
          <a:p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4FF207AB-348F-7936-A552-F782B788735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36406" y="241896"/>
            <a:ext cx="6353175" cy="4876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564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95f1b23-abaf-45ee-821d-b7ab251ab3bf}" enabled="0" method="" siteId="{e95f1b23-abaf-45ee-821d-b7ab251ab3b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obel, Raymond</dc:creator>
  <cp:lastModifiedBy>Sobel, Raymond</cp:lastModifiedBy>
  <cp:revision>1</cp:revision>
  <dcterms:created xsi:type="dcterms:W3CDTF">2025-11-02T21:18:12Z</dcterms:created>
  <dcterms:modified xsi:type="dcterms:W3CDTF">2025-11-02T22:26:29Z</dcterms:modified>
</cp:coreProperties>
</file>